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90" d="100"/>
          <a:sy n="90" d="100"/>
        </p:scale>
        <p:origin x="-73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13A8B4-8B48-408A-9DB2-746E8C8F0234}" type="datetimeFigureOut">
              <a:rPr lang="en-US" smtClean="0"/>
              <a:pPr/>
              <a:t>12/9/20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1B3DDE-A3CD-4022-A424-D6444E0414BA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71539" y="1357298"/>
            <a:ext cx="7929617" cy="27840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285720" y="1439369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00" dirty="0" smtClean="0">
                <a:latin typeface="Times New Roman" pitchFamily="18" charset="0"/>
                <a:cs typeface="Times New Roman" pitchFamily="18" charset="0"/>
              </a:rPr>
              <a:t>AJ13355</a:t>
            </a:r>
            <a:endParaRPr lang="en-ZA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80937" y="2214554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00" dirty="0" smtClean="0">
                <a:latin typeface="Times New Roman" pitchFamily="18" charset="0"/>
                <a:cs typeface="Times New Roman" pitchFamily="18" charset="0"/>
              </a:rPr>
              <a:t>LMG20103</a:t>
            </a:r>
            <a:endParaRPr lang="en-ZA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85720" y="2979098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00" dirty="0" smtClean="0">
                <a:latin typeface="Times New Roman" pitchFamily="18" charset="0"/>
                <a:cs typeface="Times New Roman" pitchFamily="18" charset="0"/>
              </a:rPr>
              <a:t>LMG5342</a:t>
            </a:r>
            <a:endParaRPr lang="en-ZA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5720" y="3764916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00" dirty="0" smtClean="0">
                <a:latin typeface="Times New Roman" pitchFamily="18" charset="0"/>
                <a:cs typeface="Times New Roman" pitchFamily="18" charset="0"/>
              </a:rPr>
              <a:t>PA13</a:t>
            </a:r>
            <a:endParaRPr lang="en-ZA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357454" y="4357694"/>
            <a:ext cx="4572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ure S1 Genome alignment showing extensive synteny between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P. ananatis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enomes</a:t>
            </a:r>
            <a:endParaRPr lang="en-ZA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7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ieter</dc:creator>
  <cp:lastModifiedBy>Pieter</cp:lastModifiedBy>
  <cp:revision>2</cp:revision>
  <dcterms:created xsi:type="dcterms:W3CDTF">2013-02-27T08:56:24Z</dcterms:created>
  <dcterms:modified xsi:type="dcterms:W3CDTF">2013-12-09T11:57:30Z</dcterms:modified>
</cp:coreProperties>
</file>